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5.jpeg" ContentType="image/jpeg"/>
  <Override PartName="/ppt/media/image14.jpeg" ContentType="image/jpeg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12.jpeg" ContentType="image/jpeg"/>
  <Override PartName="/ppt/media/image10.jpeg" ContentType="image/jpeg"/>
  <Override PartName="/ppt/media/image8.jpeg" ContentType="image/jpeg"/>
  <Override PartName="/ppt/media/image13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C396DD-4B0D-4528-92D4-FE0D72EB56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55A550-F9D5-40A7-ABF1-4418C44018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C35388-9ADB-40FC-A499-3BE750D2DD0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8893A1-1634-4289-90C6-F82556E3B75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E00720-3EEE-4D99-8FD0-F0FE86BAAD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48D175-9F5F-4798-B5C5-6D02BE0AE0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2E3142-23F0-478A-B379-16C9069CC2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0A3B1E-9986-437F-83A3-9B86DC21E1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97E63B-D0E4-4211-95CF-13F01DEBAD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92D511-9A89-4FF7-B2B4-84B133F289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1A661C-3722-40B9-A90C-690BE9BBA9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05ED9E-D254-4A1D-B330-9E39B1B1A0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C6CAC3-D004-4634-A4D5-739540598AA4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image" Target="../media/image7.jpeg"/><Relationship Id="rId4" Type="http://schemas.openxmlformats.org/officeDocument/2006/relationships/image" Target="../media/image8.jpe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image" Target="../media/image10.jpeg"/><Relationship Id="rId3" Type="http://schemas.openxmlformats.org/officeDocument/2006/relationships/image" Target="../media/image11.jpeg"/><Relationship Id="rId4" Type="http://schemas.openxmlformats.org/officeDocument/2006/relationships/image" Target="../media/image12.jpeg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image" Target="../media/image14.jpeg"/><Relationship Id="rId3" Type="http://schemas.openxmlformats.org/officeDocument/2006/relationships/image" Target="../media/image15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55680" y="560520"/>
            <a:ext cx="6130800" cy="7956360"/>
            <a:chOff x="355680" y="560520"/>
            <a:chExt cx="6130800" cy="7956360"/>
          </a:xfrm>
        </p:grpSpPr>
        <p:pic>
          <p:nvPicPr>
            <p:cNvPr id="42" name="Picture 10" descr="C:\Users\INRA\Desktop\Ivraie\qPCR-Ivraie\qPCR-Ivraie-Stabilité gènes\ARCHIPEL\Fichiers bruts\Figures melt curves\TUBU.jpg"/>
            <p:cNvPicPr/>
            <p:nvPr/>
          </p:nvPicPr>
          <p:blipFill>
            <a:blip r:embed="rId1"/>
            <a:srcRect l="0" t="3506" r="0" b="8773"/>
            <a:stretch/>
          </p:blipFill>
          <p:spPr>
            <a:xfrm>
              <a:off x="355680" y="609480"/>
              <a:ext cx="3060720" cy="3675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12" descr="C:\Users\INRA\Desktop\Ivraie\qPCR-Ivraie\qPCR-Ivraie-Stabilité gènes\ARCHIPEL\Fichiers bruts\Figures melt curves\EF1.jpg"/>
            <p:cNvPicPr/>
            <p:nvPr/>
          </p:nvPicPr>
          <p:blipFill>
            <a:blip r:embed="rId2"/>
            <a:srcRect l="0" t="2820" r="0" b="8479"/>
            <a:stretch/>
          </p:blipFill>
          <p:spPr>
            <a:xfrm>
              <a:off x="358920" y="4800600"/>
              <a:ext cx="3058920" cy="3716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14" descr="C:\Users\INRA\Desktop\Ivraie\qPCR-Ivraie\qPCR-Ivraie-Stabilité gènes\ARCHIPEL\Fichiers bruts\Figures melt curves\CAP.jpg"/>
            <p:cNvPicPr/>
            <p:nvPr/>
          </p:nvPicPr>
          <p:blipFill>
            <a:blip r:embed="rId3"/>
            <a:srcRect l="0" t="2407" r="0" b="8897"/>
            <a:stretch/>
          </p:blipFill>
          <p:spPr>
            <a:xfrm>
              <a:off x="3427560" y="560520"/>
              <a:ext cx="3058920" cy="3716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15" descr="C:\Users\INRA\Desktop\Ivraie\qPCR-Ivraie\qPCR-Ivraie-Stabilité gènes\ARCHIPEL\Fichiers bruts\Figures melt curves\GAPDH.jpg"/>
            <p:cNvPicPr/>
            <p:nvPr/>
          </p:nvPicPr>
          <p:blipFill>
            <a:blip r:embed="rId4"/>
            <a:srcRect l="0" t="2651" r="0" b="8648"/>
            <a:stretch/>
          </p:blipFill>
          <p:spPr>
            <a:xfrm>
              <a:off x="3419640" y="4788000"/>
              <a:ext cx="3060360" cy="3716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ZoneTexte 17"/>
            <p:cNvSpPr/>
            <p:nvPr/>
          </p:nvSpPr>
          <p:spPr>
            <a:xfrm>
              <a:off x="793800" y="620640"/>
              <a:ext cx="906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UB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ZoneTexte 19"/>
            <p:cNvSpPr/>
            <p:nvPr/>
          </p:nvSpPr>
          <p:spPr>
            <a:xfrm>
              <a:off x="3868560" y="620640"/>
              <a:ext cx="928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(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P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ZoneTexte 20"/>
            <p:cNvSpPr/>
            <p:nvPr/>
          </p:nvSpPr>
          <p:spPr>
            <a:xfrm>
              <a:off x="803160" y="4842000"/>
              <a:ext cx="897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F1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ZoneTexte 21"/>
            <p:cNvSpPr/>
            <p:nvPr/>
          </p:nvSpPr>
          <p:spPr>
            <a:xfrm>
              <a:off x="3859200" y="4844880"/>
              <a:ext cx="1082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"/>
          <p:cNvGrpSpPr/>
          <p:nvPr/>
        </p:nvGrpSpPr>
        <p:grpSpPr>
          <a:xfrm>
            <a:off x="351000" y="606600"/>
            <a:ext cx="6132240" cy="7913520"/>
            <a:chOff x="351000" y="606600"/>
            <a:chExt cx="6132240" cy="7913520"/>
          </a:xfrm>
        </p:grpSpPr>
        <p:pic>
          <p:nvPicPr>
            <p:cNvPr id="51" name="Picture 2" descr="C:\Users\INRA\Desktop\Ivraie\qPCR-Ivraie\qPCR-Ivraie-Stabilité gènes\ARCHIPEL\Fichiers bruts\Figures melt curves\RUB.jpg"/>
            <p:cNvPicPr/>
            <p:nvPr/>
          </p:nvPicPr>
          <p:blipFill>
            <a:blip r:embed="rId1"/>
            <a:srcRect l="0" t="2959" r="0" b="8340"/>
            <a:stretch/>
          </p:blipFill>
          <p:spPr>
            <a:xfrm>
              <a:off x="351000" y="606600"/>
              <a:ext cx="3060360" cy="3716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4" descr="C:\Users\INRA\Desktop\Ivraie\qPCR-Ivraie\qPCR-Ivraie-Stabilité gènes\ARCHIPEL\Fichiers bruts\Figures melt curves\18S.jpg"/>
            <p:cNvPicPr/>
            <p:nvPr/>
          </p:nvPicPr>
          <p:blipFill>
            <a:blip r:embed="rId2"/>
            <a:srcRect l="0" t="3168" r="0" b="9245"/>
            <a:stretch/>
          </p:blipFill>
          <p:spPr>
            <a:xfrm>
              <a:off x="352440" y="4849920"/>
              <a:ext cx="3058920" cy="3670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5" descr="C:\Users\INRA\Desktop\Ivraie\qPCR-Ivraie\qPCR-Ivraie-Stabilité gènes\ARCHIPEL\Fichiers bruts\Figures melt curves\25S.jpg"/>
            <p:cNvPicPr/>
            <p:nvPr/>
          </p:nvPicPr>
          <p:blipFill>
            <a:blip r:embed="rId3"/>
            <a:srcRect l="0" t="3093" r="0" b="9320"/>
            <a:stretch/>
          </p:blipFill>
          <p:spPr>
            <a:xfrm>
              <a:off x="3424320" y="4849920"/>
              <a:ext cx="3058920" cy="3670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6" descr="C:\Users\INRA\Desktop\Ivraie\qPCR-Ivraie\qPCR-Ivraie-Stabilité gènes\ARCHIPEL\Fichiers bruts\Figures melt curves\UBQ.jpg"/>
            <p:cNvPicPr/>
            <p:nvPr/>
          </p:nvPicPr>
          <p:blipFill>
            <a:blip r:embed="rId4"/>
            <a:srcRect l="0" t="2780" r="0" b="8519"/>
            <a:stretch/>
          </p:blipFill>
          <p:spPr>
            <a:xfrm>
              <a:off x="3419640" y="606600"/>
              <a:ext cx="3060360" cy="3716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ZoneTexte 8"/>
            <p:cNvSpPr/>
            <p:nvPr/>
          </p:nvSpPr>
          <p:spPr>
            <a:xfrm>
              <a:off x="803160" y="4876920"/>
              <a:ext cx="1113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8S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ZoneTexte 9"/>
            <p:cNvSpPr/>
            <p:nvPr/>
          </p:nvSpPr>
          <p:spPr>
            <a:xfrm>
              <a:off x="793800" y="655560"/>
              <a:ext cx="11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E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(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RUB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ZoneTexte 10"/>
            <p:cNvSpPr/>
            <p:nvPr/>
          </p:nvSpPr>
          <p:spPr>
            <a:xfrm>
              <a:off x="3860640" y="655560"/>
              <a:ext cx="1008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UBQ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ZoneTexte 11"/>
            <p:cNvSpPr/>
            <p:nvPr/>
          </p:nvSpPr>
          <p:spPr>
            <a:xfrm>
              <a:off x="3860640" y="488484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S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"/>
          <p:cNvGrpSpPr/>
          <p:nvPr/>
        </p:nvGrpSpPr>
        <p:grpSpPr>
          <a:xfrm>
            <a:off x="352440" y="577800"/>
            <a:ext cx="6127560" cy="7988400"/>
            <a:chOff x="352440" y="577800"/>
            <a:chExt cx="6127560" cy="7988400"/>
          </a:xfrm>
        </p:grpSpPr>
        <p:pic>
          <p:nvPicPr>
            <p:cNvPr id="60" name="Picture 2" descr="C:\Users\INRA\Desktop\Ivraie\qPCR-Ivraie\qPCR-échantillonnages Target genes\Melt Curves\ACCase.jpg"/>
            <p:cNvPicPr/>
            <p:nvPr/>
          </p:nvPicPr>
          <p:blipFill>
            <a:blip r:embed="rId1"/>
            <a:srcRect l="0" t="3392" r="0" b="9016"/>
            <a:stretch/>
          </p:blipFill>
          <p:spPr>
            <a:xfrm>
              <a:off x="3419640" y="620640"/>
              <a:ext cx="3060360" cy="3670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Picture 4" descr="C:\Users\INRA\Desktop\Ivraie\qPCR-Ivraie\qPCR-échantillonnages Target genes\Melt Curves\C71R4.jpg"/>
            <p:cNvPicPr/>
            <p:nvPr/>
          </p:nvPicPr>
          <p:blipFill>
            <a:blip r:embed="rId2"/>
            <a:srcRect l="0" t="3496" r="0" b="8912"/>
            <a:stretch/>
          </p:blipFill>
          <p:spPr>
            <a:xfrm>
              <a:off x="352440" y="4853160"/>
              <a:ext cx="3058920" cy="3670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5" descr="C:\Users\INRA\Desktop\Ivraie\qPCR-Ivraie\qPCR-échantillonnages Target genes\Melt Curves\C72A.jpg"/>
            <p:cNvPicPr/>
            <p:nvPr/>
          </p:nvPicPr>
          <p:blipFill>
            <a:blip r:embed="rId3"/>
            <a:srcRect l="0" t="3228" r="0" b="8071"/>
            <a:stretch/>
          </p:blipFill>
          <p:spPr>
            <a:xfrm>
              <a:off x="3419640" y="4849920"/>
              <a:ext cx="3060360" cy="3716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Picture 10" descr="C:\Users\INRA\Desktop\Ivraie\qPCR-Ivraie\qPCR-échantillonnages Target genes\Melt Curves\ALS.jpg"/>
            <p:cNvPicPr/>
            <p:nvPr/>
          </p:nvPicPr>
          <p:blipFill>
            <a:blip r:embed="rId4"/>
            <a:srcRect l="0" t="3004" r="0" b="0"/>
            <a:stretch/>
          </p:blipFill>
          <p:spPr>
            <a:xfrm>
              <a:off x="357120" y="577800"/>
              <a:ext cx="3059280" cy="3700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4" name="ZoneTexte 12"/>
            <p:cNvSpPr/>
            <p:nvPr/>
          </p:nvSpPr>
          <p:spPr>
            <a:xfrm>
              <a:off x="3860640" y="655560"/>
              <a:ext cx="1152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J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CCase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ZoneTexte 13"/>
            <p:cNvSpPr/>
            <p:nvPr/>
          </p:nvSpPr>
          <p:spPr>
            <a:xfrm>
              <a:off x="792000" y="636480"/>
              <a:ext cx="908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LS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ZoneTexte 14"/>
            <p:cNvSpPr/>
            <p:nvPr/>
          </p:nvSpPr>
          <p:spPr>
            <a:xfrm>
              <a:off x="793800" y="4869000"/>
              <a:ext cx="12668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K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P71R4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ZoneTexte 15"/>
            <p:cNvSpPr/>
            <p:nvPr/>
          </p:nvSpPr>
          <p:spPr>
            <a:xfrm>
              <a:off x="3860640" y="4869000"/>
              <a:ext cx="1081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P72A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8" name=""/>
          <p:cNvGrpSpPr/>
          <p:nvPr/>
        </p:nvGrpSpPr>
        <p:grpSpPr>
          <a:xfrm>
            <a:off x="352440" y="539640"/>
            <a:ext cx="6388200" cy="8045640"/>
            <a:chOff x="352440" y="539640"/>
            <a:chExt cx="6388200" cy="8045640"/>
          </a:xfrm>
        </p:grpSpPr>
        <p:pic>
          <p:nvPicPr>
            <p:cNvPr id="69" name="Picture 2" descr="C:\Users\INRA\Desktop\Ivraie\qPCR-Ivraie\qPCR-échantillonnages Target genes\Melt Curves\C81A.jpg"/>
            <p:cNvPicPr/>
            <p:nvPr/>
          </p:nvPicPr>
          <p:blipFill>
            <a:blip r:embed="rId1"/>
            <a:srcRect l="0" t="3327" r="0" b="9081"/>
            <a:stretch/>
          </p:blipFill>
          <p:spPr>
            <a:xfrm>
              <a:off x="3419640" y="542880"/>
              <a:ext cx="3060360" cy="3668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Picture 3" descr="C:\Users\INRA\Desktop\Ivraie\qPCR-Ivraie\qPCR-échantillonnages Target genes\Melt Curves\C81B1.jpg"/>
            <p:cNvPicPr/>
            <p:nvPr/>
          </p:nvPicPr>
          <p:blipFill>
            <a:blip r:embed="rId2"/>
            <a:srcRect l="0" t="2989" r="0" b="8310"/>
            <a:stretch/>
          </p:blipFill>
          <p:spPr>
            <a:xfrm>
              <a:off x="352440" y="539640"/>
              <a:ext cx="3058920" cy="3716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Picture 4" descr="C:\Users\INRA\Desktop\Ivraie\qPCR-Ivraie\qPCR-échantillonnages Target genes\Melt Curves\C92A.jpg"/>
            <p:cNvPicPr/>
            <p:nvPr/>
          </p:nvPicPr>
          <p:blipFill>
            <a:blip r:embed="rId3"/>
            <a:srcRect l="0" t="2909" r="0" b="8390"/>
            <a:stretch/>
          </p:blipFill>
          <p:spPr>
            <a:xfrm>
              <a:off x="358920" y="4869000"/>
              <a:ext cx="3060720" cy="3716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ZoneTexte 6"/>
            <p:cNvSpPr/>
            <p:nvPr/>
          </p:nvSpPr>
          <p:spPr>
            <a:xfrm>
              <a:off x="803160" y="4906800"/>
              <a:ext cx="1546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O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(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P92A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ZoneTexte 7"/>
            <p:cNvSpPr/>
            <p:nvPr/>
          </p:nvSpPr>
          <p:spPr>
            <a:xfrm>
              <a:off x="793800" y="573120"/>
              <a:ext cx="1627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P81B1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ZoneTexte 8"/>
            <p:cNvSpPr/>
            <p:nvPr/>
          </p:nvSpPr>
          <p:spPr>
            <a:xfrm>
              <a:off x="3860640" y="568440"/>
              <a:ext cx="1656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(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P81A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500280" y="7308720"/>
              <a:ext cx="3240360" cy="1189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igure S1 – Primer specificity test.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lting curves generated for </a:t>
              </a:r>
              <a:r>
                <a:rPr b="0" i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UB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A),</a:t>
              </a:r>
              <a:r>
                <a:rPr b="0" i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CAP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B),</a:t>
              </a:r>
              <a:r>
                <a:rPr b="0" i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EF1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C), </a:t>
              </a:r>
              <a:r>
                <a:rPr b="0" i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D),</a:t>
              </a:r>
              <a:r>
                <a:rPr b="0" i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RUB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E),</a:t>
              </a:r>
              <a:r>
                <a:rPr b="0" i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UBQ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F),</a:t>
              </a:r>
              <a:r>
                <a:rPr b="0" i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18S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G), </a:t>
              </a:r>
              <a:r>
                <a:rPr b="0" i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S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H),</a:t>
              </a:r>
              <a:r>
                <a:rPr b="0" i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ALS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I),</a:t>
              </a:r>
              <a:r>
                <a:rPr b="0" i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ACCase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J),</a:t>
              </a:r>
              <a:r>
                <a:rPr b="0" i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CYP71R4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K),</a:t>
              </a:r>
              <a:r>
                <a:rPr b="0" i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CYP72A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L),</a:t>
              </a:r>
              <a:r>
                <a:rPr b="0" i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CYP81B1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M), </a:t>
              </a:r>
              <a:r>
                <a:rPr b="0" i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P81A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N),</a:t>
              </a:r>
              <a:r>
                <a:rPr b="0" i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CYP92A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O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13T16:45:45Z</dcterms:created>
  <dc:creator>Arnaud Duhoux</dc:creator>
  <dc:description/>
  <dc:language>en-US</dc:language>
  <cp:lastModifiedBy>Christophe Délye</cp:lastModifiedBy>
  <dcterms:modified xsi:type="dcterms:W3CDTF">2013-04-16T14:20:43Z</dcterms:modified>
  <cp:revision>21</cp:revision>
  <dc:subject/>
  <dc:title>Diapositive 1</dc:title>
</cp:coreProperties>
</file>